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5" d="100"/>
          <a:sy n="75" d="100"/>
        </p:scale>
        <p:origin x="-1818" y="-78"/>
      </p:cViewPr>
      <p:guideLst>
        <p:guide orient="horz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FB04-EB3D-402A-914A-A7EC02286B93}" type="datetimeFigureOut">
              <a:rPr lang="en-GB" smtClean="0"/>
              <a:pPr/>
              <a:t>2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B5F5B-8DD0-4BC7-80C0-552C54A58A0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4345279"/>
            <a:ext cx="68580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 smtClean="0"/>
              <a:t>Figure S1</a:t>
            </a:r>
            <a:r>
              <a:rPr lang="en-GB" sz="1100" b="1" dirty="0" smtClean="0"/>
              <a:t>. Macroscopic analyses of the </a:t>
            </a:r>
            <a:r>
              <a:rPr lang="en-GB" sz="1100" b="1" i="1" dirty="0" err="1" smtClean="0"/>
              <a:t>ColIITg</a:t>
            </a:r>
            <a:r>
              <a:rPr lang="en-GB" sz="1100" b="1" i="1" baseline="30000" dirty="0" err="1" smtClean="0"/>
              <a:t>cog</a:t>
            </a:r>
            <a:r>
              <a:rPr lang="en-GB" sz="1100" b="1" dirty="0" smtClean="0"/>
              <a:t> mouse phenotype (female mice)</a:t>
            </a:r>
          </a:p>
          <a:p>
            <a:pPr algn="just"/>
            <a:r>
              <a:rPr lang="en-GB" sz="1100" dirty="0" smtClean="0"/>
              <a:t>(A) Graph and table of body weights and percentage differences of female +/+ and c/c mice at 3, 6 and 9 weeks of age (mean ± SEM (n)). There was a significant effect of genotype having corrected for age and gender (F</a:t>
            </a:r>
            <a:r>
              <a:rPr lang="en-GB" sz="1100" baseline="-25000" dirty="0" smtClean="0"/>
              <a:t>1, 318</a:t>
            </a:r>
            <a:r>
              <a:rPr lang="en-GB" sz="1100" dirty="0" smtClean="0"/>
              <a:t> = 1330.2, P &lt; 0.0001). (B) Graph and table of femur lengths and percentage differences between +/+ and c/c female mice at 3, 6 and 9 weeks of age (mean ± SEM (n)). There was a significant effect of genotype having corrected for age and gender (F</a:t>
            </a:r>
            <a:r>
              <a:rPr lang="en-GB" sz="1100" baseline="-25000" dirty="0" smtClean="0"/>
              <a:t>1, 186</a:t>
            </a:r>
            <a:r>
              <a:rPr lang="en-GB" sz="1100" dirty="0" smtClean="0"/>
              <a:t> = 55.48, P &lt; 0.0001). </a:t>
            </a:r>
            <a:endParaRPr lang="en-GB" sz="1100" dirty="0"/>
          </a:p>
        </p:txBody>
      </p: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222460" y="1080821"/>
            <a:ext cx="427037" cy="33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GB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A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3270445" y="1080821"/>
            <a:ext cx="427038" cy="33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GB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B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25546" y="1353775"/>
            <a:ext cx="2545356" cy="189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705226" y="1353775"/>
            <a:ext cx="2829057" cy="189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747129" y="3315925"/>
            <a:ext cx="2745251" cy="9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59923" y="3312272"/>
            <a:ext cx="3082123" cy="9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32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ou</dc:creator>
  <cp:lastModifiedBy>Lou</cp:lastModifiedBy>
  <cp:revision>5</cp:revision>
  <dcterms:created xsi:type="dcterms:W3CDTF">2014-05-20T13:31:33Z</dcterms:created>
  <dcterms:modified xsi:type="dcterms:W3CDTF">2014-11-24T14:36:13Z</dcterms:modified>
</cp:coreProperties>
</file>